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2">
  <p:sldMasterIdLst>
    <p:sldMasterId id="2147483648" r:id="rId1"/>
  </p:sldMasterIdLst>
  <p:notesMasterIdLst>
    <p:notesMasterId r:id="rId3"/>
  </p:notesMasterIdLst>
  <p:sldIdLst>
    <p:sldId id="29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091" userDrawn="1">
          <p15:clr>
            <a:srgbClr val="A4A3A4"/>
          </p15:clr>
        </p15:guide>
        <p15:guide id="2" pos="4201" userDrawn="1">
          <p15:clr>
            <a:srgbClr val="A4A3A4"/>
          </p15:clr>
        </p15:guide>
        <p15:guide id="3" pos="164" userDrawn="1">
          <p15:clr>
            <a:srgbClr val="A4A3A4"/>
          </p15:clr>
        </p15:guide>
        <p15:guide id="4" orient="horz" pos="308" userDrawn="1">
          <p15:clr>
            <a:srgbClr val="A4A3A4"/>
          </p15:clr>
        </p15:guide>
        <p15:guide id="5" orient="horz" pos="314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ophia Karagiannis" initials="SK" lastIdx="11" clrIdx="0"/>
  <p:cmAuthor id="1" name="Heather Bax" initials="" lastIdx="7" clrIdx="1"/>
  <p:cmAuthor id="2" name="Mano Nakamura" initials="MN" lastIdx="15" clrIdx="2"/>
  <p:cmAuthor id="3" name="Mano Nakamura" initials="MN [2]" lastIdx="1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D7E5"/>
    <a:srgbClr val="D3D3D3"/>
    <a:srgbClr val="FFA600"/>
    <a:srgbClr val="FF89C9"/>
    <a:srgbClr val="807FFF"/>
    <a:srgbClr val="EDA777"/>
    <a:srgbClr val="ED985F"/>
    <a:srgbClr val="FF9300"/>
    <a:srgbClr val="FCC762"/>
    <a:srgbClr val="F9B76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88"/>
    <p:restoredTop sz="95701" autoAdjust="0"/>
  </p:normalViewPr>
  <p:slideViewPr>
    <p:cSldViewPr snapToGrid="0" snapToObjects="1">
      <p:cViewPr varScale="1">
        <p:scale>
          <a:sx n="68" d="100"/>
          <a:sy n="68" d="100"/>
        </p:scale>
        <p:origin x="2304" y="224"/>
      </p:cViewPr>
      <p:guideLst>
        <p:guide orient="horz" pos="6091"/>
        <p:guide pos="4201"/>
        <p:guide pos="164"/>
        <p:guide orient="horz" pos="308"/>
        <p:guide orient="horz" pos="314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0DFCED-7969-774D-899A-31ED0E8BA5BF}" type="datetimeFigureOut">
              <a:rPr lang="en-US" smtClean="0"/>
              <a:t>12/18/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231591-98D7-1E4A-AE1D-67BDB0AEDE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96255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231591-98D7-1E4A-AE1D-67BDB0AEDEDD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15548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AT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00183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69710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04772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68646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A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45677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6245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A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A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10570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0717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30306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98317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70727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AT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1A8EC-78B0-7545-90C0-3241C215DBE7}" type="datetimeFigureOut">
              <a:rPr lang="en-US" smtClean="0"/>
              <a:t>12/18/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001A7-2C28-244C-967F-D393C69E932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5039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F393E3DE-D573-E640-B2E9-C2FB0C536527}"/>
              </a:ext>
            </a:extLst>
          </p:cNvPr>
          <p:cNvGrpSpPr/>
          <p:nvPr/>
        </p:nvGrpSpPr>
        <p:grpSpPr>
          <a:xfrm>
            <a:off x="1213318" y="488950"/>
            <a:ext cx="4450565" cy="6780758"/>
            <a:chOff x="1229943" y="954950"/>
            <a:chExt cx="4450565" cy="6780758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E1AD1C8-41DE-BA41-811B-DAC7CC875CA0}"/>
                </a:ext>
              </a:extLst>
            </p:cNvPr>
            <p:cNvSpPr txBox="1"/>
            <p:nvPr/>
          </p:nvSpPr>
          <p:spPr>
            <a:xfrm>
              <a:off x="1346544" y="2546343"/>
              <a:ext cx="4189330" cy="276999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urvival analysis using Kaplan-Meier Plotter</a:t>
              </a:r>
            </a:p>
          </p:txBody>
        </p:sp>
        <p:sp>
          <p:nvSpPr>
            <p:cNvPr id="25" name="Rounded Rectangle 24">
              <a:extLst>
                <a:ext uri="{FF2B5EF4-FFF2-40B4-BE49-F238E27FC236}">
                  <a16:creationId xmlns:a16="http://schemas.microsoft.com/office/drawing/2014/main" id="{9F9AFB4C-B811-124A-8FA1-06C5A3B4C618}"/>
                </a:ext>
              </a:extLst>
            </p:cNvPr>
            <p:cNvSpPr/>
            <p:nvPr/>
          </p:nvSpPr>
          <p:spPr>
            <a:xfrm>
              <a:off x="1365222" y="2540147"/>
              <a:ext cx="4097065" cy="313157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6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E70C181-CF1D-C44C-A0B8-19BAE34EDD64}"/>
                </a:ext>
              </a:extLst>
            </p:cNvPr>
            <p:cNvSpPr txBox="1"/>
            <p:nvPr/>
          </p:nvSpPr>
          <p:spPr>
            <a:xfrm>
              <a:off x="1586681" y="2948514"/>
              <a:ext cx="3724381" cy="46166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ene expression data from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,656 ovarian cancer patients</a:t>
              </a:r>
            </a:p>
          </p:txBody>
        </p:sp>
        <p:sp>
          <p:nvSpPr>
            <p:cNvPr id="23" name="Rounded Rectangle 22">
              <a:extLst>
                <a:ext uri="{FF2B5EF4-FFF2-40B4-BE49-F238E27FC236}">
                  <a16:creationId xmlns:a16="http://schemas.microsoft.com/office/drawing/2014/main" id="{B8106304-30EE-5347-B7CD-C60DA2BBE0B6}"/>
                </a:ext>
              </a:extLst>
            </p:cNvPr>
            <p:cNvSpPr/>
            <p:nvPr/>
          </p:nvSpPr>
          <p:spPr>
            <a:xfrm>
              <a:off x="1599513" y="2935560"/>
              <a:ext cx="3670687" cy="470691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4AD938B-09AD-134D-A9B5-6C52217F007F}"/>
                </a:ext>
              </a:extLst>
            </p:cNvPr>
            <p:cNvSpPr txBox="1"/>
            <p:nvPr/>
          </p:nvSpPr>
          <p:spPr>
            <a:xfrm>
              <a:off x="1489398" y="4856101"/>
              <a:ext cx="3848711" cy="2769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linical 5-year Overall Survival (OS)</a:t>
              </a:r>
            </a:p>
          </p:txBody>
        </p:sp>
        <p:sp>
          <p:nvSpPr>
            <p:cNvPr id="18" name="Rounded Rectangle 17">
              <a:extLst>
                <a:ext uri="{FF2B5EF4-FFF2-40B4-BE49-F238E27FC236}">
                  <a16:creationId xmlns:a16="http://schemas.microsoft.com/office/drawing/2014/main" id="{8969E3E2-0CBA-9E44-8B3F-07771CF576F6}"/>
                </a:ext>
              </a:extLst>
            </p:cNvPr>
            <p:cNvSpPr/>
            <p:nvPr/>
          </p:nvSpPr>
          <p:spPr>
            <a:xfrm>
              <a:off x="1578249" y="4826526"/>
              <a:ext cx="3691952" cy="291246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138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ounded Rectangle 8">
              <a:extLst>
                <a:ext uri="{FF2B5EF4-FFF2-40B4-BE49-F238E27FC236}">
                  <a16:creationId xmlns:a16="http://schemas.microsoft.com/office/drawing/2014/main" id="{076B5464-0DA3-0047-BF5C-B817A04232C2}"/>
                </a:ext>
              </a:extLst>
            </p:cNvPr>
            <p:cNvSpPr/>
            <p:nvPr/>
          </p:nvSpPr>
          <p:spPr>
            <a:xfrm>
              <a:off x="1573847" y="5609753"/>
              <a:ext cx="3696353" cy="527445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138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C00886C5-CCA9-7047-8B9D-FF632E7B1885}"/>
                </a:ext>
              </a:extLst>
            </p:cNvPr>
            <p:cNvSpPr/>
            <p:nvPr/>
          </p:nvSpPr>
          <p:spPr>
            <a:xfrm>
              <a:off x="1694732" y="5613540"/>
              <a:ext cx="3429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 total of 1,978 combinations of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mmune mediators tested</a:t>
              </a:r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4FF20850-0452-6042-90FE-F678591D2E64}"/>
                </a:ext>
              </a:extLst>
            </p:cNvPr>
            <p:cNvGrpSpPr/>
            <p:nvPr/>
          </p:nvGrpSpPr>
          <p:grpSpPr>
            <a:xfrm>
              <a:off x="1566383" y="6613851"/>
              <a:ext cx="3744679" cy="1121857"/>
              <a:chOff x="1334809" y="9890914"/>
              <a:chExt cx="3921631" cy="504661"/>
            </a:xfrm>
          </p:grpSpPr>
          <p:sp>
            <p:nvSpPr>
              <p:cNvPr id="15" name="Rounded Rectangle 14">
                <a:extLst>
                  <a:ext uri="{FF2B5EF4-FFF2-40B4-BE49-F238E27FC236}">
                    <a16:creationId xmlns:a16="http://schemas.microsoft.com/office/drawing/2014/main" id="{E4A17B98-72B1-B74F-AA5C-7377E3254350}"/>
                  </a:ext>
                </a:extLst>
              </p:cNvPr>
              <p:cNvSpPr/>
              <p:nvPr/>
            </p:nvSpPr>
            <p:spPr>
              <a:xfrm>
                <a:off x="1334809" y="9890914"/>
                <a:ext cx="3921631" cy="504661"/>
              </a:xfrm>
              <a:prstGeom prst="round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46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CBEFEF6-7E0F-1A44-BDB8-44ACA678D2A3}"/>
                  </a:ext>
                </a:extLst>
              </p:cNvPr>
              <p:cNvSpPr txBox="1"/>
              <p:nvPr/>
            </p:nvSpPr>
            <p:spPr>
              <a:xfrm>
                <a:off x="1349560" y="10014594"/>
                <a:ext cx="2592749" cy="20767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dentification of statistically significant associations (P &lt; 0.05)</a:t>
                </a:r>
              </a:p>
            </p:txBody>
          </p:sp>
        </p:grp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E987A2A-7C28-9840-8C76-C12D07B1F1E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79719" y="6782000"/>
              <a:ext cx="1243260" cy="785558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CEC362A-0B5F-9C4E-A220-79C6E7550327}"/>
                </a:ext>
              </a:extLst>
            </p:cNvPr>
            <p:cNvGrpSpPr/>
            <p:nvPr/>
          </p:nvGrpSpPr>
          <p:grpSpPr>
            <a:xfrm>
              <a:off x="1586681" y="3509055"/>
              <a:ext cx="3683519" cy="1227157"/>
              <a:chOff x="1334809" y="8413825"/>
              <a:chExt cx="3984370" cy="1130262"/>
            </a:xfrm>
          </p:grpSpPr>
          <p:sp>
            <p:nvSpPr>
              <p:cNvPr id="19" name="Rounded Rectangle 18">
                <a:extLst>
                  <a:ext uri="{FF2B5EF4-FFF2-40B4-BE49-F238E27FC236}">
                    <a16:creationId xmlns:a16="http://schemas.microsoft.com/office/drawing/2014/main" id="{D224ADE7-61CF-E648-98E3-8E4231DE0DC8}"/>
                  </a:ext>
                </a:extLst>
              </p:cNvPr>
              <p:cNvSpPr/>
              <p:nvPr/>
            </p:nvSpPr>
            <p:spPr>
              <a:xfrm>
                <a:off x="1334809" y="8413825"/>
                <a:ext cx="3984370" cy="1130262"/>
              </a:xfrm>
              <a:prstGeom prst="round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46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C2266BF-AE24-984C-9E55-077358ACA27C}"/>
                  </a:ext>
                </a:extLst>
              </p:cNvPr>
              <p:cNvSpPr txBox="1"/>
              <p:nvPr/>
            </p:nvSpPr>
            <p:spPr>
              <a:xfrm>
                <a:off x="1451686" y="8492150"/>
                <a:ext cx="2405206" cy="9354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tients stratified into two-cohort groups based on high (top 25%) and low (remaining 75%) expression of a given gene or gene combination</a:t>
                </a:r>
              </a:p>
            </p:txBody>
          </p:sp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8E78D95F-13CC-4A49-945C-EF5CEECCF5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90" t="11306" r="5830" b="13111"/>
              <a:stretch/>
            </p:blipFill>
            <p:spPr>
              <a:xfrm>
                <a:off x="3956245" y="8501314"/>
                <a:ext cx="1150624" cy="1023388"/>
              </a:xfrm>
              <a:prstGeom prst="rect">
                <a:avLst/>
              </a:prstGeom>
            </p:spPr>
          </p:pic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0954F4E-E3D7-144D-B238-2837E9136494}"/>
                </a:ext>
              </a:extLst>
            </p:cNvPr>
            <p:cNvSpPr txBox="1"/>
            <p:nvPr/>
          </p:nvSpPr>
          <p:spPr>
            <a:xfrm rot="16200000">
              <a:off x="3361325" y="4056729"/>
              <a:ext cx="118974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Relative gene expression</a:t>
              </a:r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D814B809-95B7-4147-B7CE-A559A58BE36B}"/>
                </a:ext>
              </a:extLst>
            </p:cNvPr>
            <p:cNvGrpSpPr/>
            <p:nvPr/>
          </p:nvGrpSpPr>
          <p:grpSpPr>
            <a:xfrm>
              <a:off x="1660261" y="1672895"/>
              <a:ext cx="3589928" cy="461665"/>
              <a:chOff x="537210" y="1748790"/>
              <a:chExt cx="4137660" cy="568203"/>
            </a:xfrm>
          </p:grpSpPr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257492C8-F18B-8B40-BF3C-F5D651B25E75}"/>
                  </a:ext>
                </a:extLst>
              </p:cNvPr>
              <p:cNvSpPr txBox="1"/>
              <p:nvPr/>
            </p:nvSpPr>
            <p:spPr>
              <a:xfrm>
                <a:off x="537210" y="1748790"/>
                <a:ext cx="4137660" cy="5682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39303" indent="-139303">
                  <a:buFont typeface="Arial" panose="020B0604020202020204" pitchFamily="34" charset="0"/>
                  <a:buChar char="•"/>
                </a:pP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4</a:t>
                </a:r>
                <a:r>
                  <a:rPr lang="en-US" sz="12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markers identified</a:t>
                </a:r>
              </a:p>
              <a:p>
                <a:pPr marL="139303" indent="-139303">
                  <a:buFont typeface="Arial" panose="020B0604020202020204" pitchFamily="34" charset="0"/>
                  <a:buChar char="•"/>
                </a:pPr>
                <a:r>
                  <a:rPr lang="en-US" sz="12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tegorised into groups based on immunity type</a:t>
                </a:r>
              </a:p>
            </p:txBody>
          </p:sp>
          <p:sp>
            <p:nvSpPr>
              <p:cNvPr id="33" name="Rounded Rectangle 32">
                <a:extLst>
                  <a:ext uri="{FF2B5EF4-FFF2-40B4-BE49-F238E27FC236}">
                    <a16:creationId xmlns:a16="http://schemas.microsoft.com/office/drawing/2014/main" id="{70B57CA1-2214-EA47-B8ED-245624BCBCE1}"/>
                  </a:ext>
                </a:extLst>
              </p:cNvPr>
              <p:cNvSpPr/>
              <p:nvPr/>
            </p:nvSpPr>
            <p:spPr>
              <a:xfrm>
                <a:off x="537210" y="1785688"/>
                <a:ext cx="4137660" cy="492441"/>
              </a:xfrm>
              <a:prstGeom prst="round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6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8CCAF3F7-A9CF-9845-98E8-35B37175A1A6}"/>
                </a:ext>
              </a:extLst>
            </p:cNvPr>
            <p:cNvGrpSpPr/>
            <p:nvPr/>
          </p:nvGrpSpPr>
          <p:grpSpPr>
            <a:xfrm>
              <a:off x="1229943" y="954950"/>
              <a:ext cx="4450565" cy="461665"/>
              <a:chOff x="497668" y="250157"/>
              <a:chExt cx="1948352" cy="1307454"/>
            </a:xfrm>
          </p:grpSpPr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62A99C56-C275-2044-B493-4D8681D036E5}"/>
                  </a:ext>
                </a:extLst>
              </p:cNvPr>
              <p:cNvSpPr txBox="1"/>
              <p:nvPr/>
            </p:nvSpPr>
            <p:spPr>
              <a:xfrm>
                <a:off x="497668" y="250157"/>
                <a:ext cx="1922617" cy="1307454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Literature review to identify immune mediators (cytokines, chemokines, growth factors, and secreted proteins)</a:t>
                </a:r>
              </a:p>
            </p:txBody>
          </p:sp>
          <p:sp>
            <p:nvSpPr>
              <p:cNvPr id="31" name="Rounded Rectangle 30">
                <a:extLst>
                  <a:ext uri="{FF2B5EF4-FFF2-40B4-BE49-F238E27FC236}">
                    <a16:creationId xmlns:a16="http://schemas.microsoft.com/office/drawing/2014/main" id="{4AAABDCF-EC3D-484D-BB42-D05D2D93BEC7}"/>
                  </a:ext>
                </a:extLst>
              </p:cNvPr>
              <p:cNvSpPr/>
              <p:nvPr/>
            </p:nvSpPr>
            <p:spPr>
              <a:xfrm>
                <a:off x="537210" y="331471"/>
                <a:ext cx="1908810" cy="1096184"/>
              </a:xfrm>
              <a:prstGeom prst="round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6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9" name="Down Arrow 28">
              <a:extLst>
                <a:ext uri="{FF2B5EF4-FFF2-40B4-BE49-F238E27FC236}">
                  <a16:creationId xmlns:a16="http://schemas.microsoft.com/office/drawing/2014/main" id="{9944109A-846E-4C47-BF5F-AE1031FAF9E3}"/>
                </a:ext>
              </a:extLst>
            </p:cNvPr>
            <p:cNvSpPr/>
            <p:nvPr/>
          </p:nvSpPr>
          <p:spPr>
            <a:xfrm>
              <a:off x="3287825" y="1428819"/>
              <a:ext cx="334800" cy="209430"/>
            </a:xfrm>
            <a:prstGeom prst="downArrow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Down Arrow 33">
              <a:extLst>
                <a:ext uri="{FF2B5EF4-FFF2-40B4-BE49-F238E27FC236}">
                  <a16:creationId xmlns:a16="http://schemas.microsoft.com/office/drawing/2014/main" id="{06687F49-0F82-FE41-9634-5E65EDFB1CE6}"/>
                </a:ext>
              </a:extLst>
            </p:cNvPr>
            <p:cNvSpPr/>
            <p:nvPr/>
          </p:nvSpPr>
          <p:spPr>
            <a:xfrm>
              <a:off x="3303039" y="2226655"/>
              <a:ext cx="334800" cy="209430"/>
            </a:xfrm>
            <a:prstGeom prst="downArrow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Down Arrow 37">
              <a:extLst>
                <a:ext uri="{FF2B5EF4-FFF2-40B4-BE49-F238E27FC236}">
                  <a16:creationId xmlns:a16="http://schemas.microsoft.com/office/drawing/2014/main" id="{579DD725-878A-DC47-AE75-7361A9828D3C}"/>
                </a:ext>
              </a:extLst>
            </p:cNvPr>
            <p:cNvSpPr/>
            <p:nvPr/>
          </p:nvSpPr>
          <p:spPr>
            <a:xfrm>
              <a:off x="3303039" y="5267286"/>
              <a:ext cx="334800" cy="209430"/>
            </a:xfrm>
            <a:prstGeom prst="downArrow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Down Arrow 38">
              <a:extLst>
                <a:ext uri="{FF2B5EF4-FFF2-40B4-BE49-F238E27FC236}">
                  <a16:creationId xmlns:a16="http://schemas.microsoft.com/office/drawing/2014/main" id="{F6F657B7-BDE5-2446-96B0-E729A905BAD9}"/>
                </a:ext>
              </a:extLst>
            </p:cNvPr>
            <p:cNvSpPr/>
            <p:nvPr/>
          </p:nvSpPr>
          <p:spPr>
            <a:xfrm>
              <a:off x="3287825" y="6275242"/>
              <a:ext cx="334800" cy="209430"/>
            </a:xfrm>
            <a:prstGeom prst="downArrow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98C91BD2-2F6C-B247-ACA4-4B3787069FA1}"/>
              </a:ext>
            </a:extLst>
          </p:cNvPr>
          <p:cNvSpPr txBox="1"/>
          <p:nvPr/>
        </p:nvSpPr>
        <p:spPr>
          <a:xfrm>
            <a:off x="539825" y="7746361"/>
            <a:ext cx="5797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orkflow for selection of immune mediator signatures and evaluation of associations with patient survival in ovarian carcinoma. </a:t>
            </a:r>
          </a:p>
        </p:txBody>
      </p:sp>
    </p:spTree>
    <p:extLst>
      <p:ext uri="{BB962C8B-B14F-4D97-AF65-F5344CB8AC3E}">
        <p14:creationId xmlns:p14="http://schemas.microsoft.com/office/powerpoint/2010/main" val="1250486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806</TotalTime>
  <Words>119</Words>
  <Application>Microsoft Macintosh PowerPoint</Application>
  <PresentationFormat>A4 Paper (210x297 mm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agiotis Karagiannis</dc:creator>
  <cp:lastModifiedBy>Mano Nakamura</cp:lastModifiedBy>
  <cp:revision>486</cp:revision>
  <cp:lastPrinted>2018-12-16T14:33:58Z</cp:lastPrinted>
  <dcterms:created xsi:type="dcterms:W3CDTF">2017-11-17T17:56:42Z</dcterms:created>
  <dcterms:modified xsi:type="dcterms:W3CDTF">2018-12-18T12:30:41Z</dcterms:modified>
</cp:coreProperties>
</file>